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6" autoAdjust="0"/>
    <p:restoredTop sz="94660"/>
  </p:normalViewPr>
  <p:slideViewPr>
    <p:cSldViewPr snapToGrid="0">
      <p:cViewPr varScale="1">
        <p:scale>
          <a:sx n="87" d="100"/>
          <a:sy n="87" d="100"/>
        </p:scale>
        <p:origin x="4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devos\Dropbox\UGA\IPBGG\Hanieh\FInal%20results\resultsrun27K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run27K5 (2)'!$O$3:$O$90</c:f>
              <c:strCache>
                <c:ptCount val="88"/>
                <c:pt idx="0">
                  <c:v>E_O_75</c:v>
                </c:pt>
                <c:pt idx="1">
                  <c:v>E_O_76</c:v>
                </c:pt>
                <c:pt idx="2">
                  <c:v>E_O_77</c:v>
                </c:pt>
                <c:pt idx="3">
                  <c:v>E_O_73</c:v>
                </c:pt>
                <c:pt idx="4">
                  <c:v>E_O_SB</c:v>
                </c:pt>
                <c:pt idx="5">
                  <c:v>E_O_SB4</c:v>
                </c:pt>
                <c:pt idx="6">
                  <c:v>E_O_57</c:v>
                </c:pt>
                <c:pt idx="7">
                  <c:v>E_O_56</c:v>
                </c:pt>
                <c:pt idx="8">
                  <c:v>E_O_59</c:v>
                </c:pt>
                <c:pt idx="9">
                  <c:v>E_O_58</c:v>
                </c:pt>
                <c:pt idx="10">
                  <c:v>E_GH7</c:v>
                </c:pt>
                <c:pt idx="11">
                  <c:v>E_HZ6</c:v>
                </c:pt>
                <c:pt idx="12">
                  <c:v>E_O_sb5</c:v>
                </c:pt>
                <c:pt idx="13">
                  <c:v>E_HZ4</c:v>
                </c:pt>
                <c:pt idx="14">
                  <c:v>E_KELIDAR_69</c:v>
                </c:pt>
                <c:pt idx="15">
                  <c:v>E_O_74</c:v>
                </c:pt>
                <c:pt idx="16">
                  <c:v>E_S_KN1</c:v>
                </c:pt>
                <c:pt idx="17">
                  <c:v>E_O_SB6</c:v>
                </c:pt>
                <c:pt idx="18">
                  <c:v>E_O_55</c:v>
                </c:pt>
                <c:pt idx="19">
                  <c:v>E_O_60</c:v>
                </c:pt>
                <c:pt idx="20">
                  <c:v>E_S_KN6</c:v>
                </c:pt>
                <c:pt idx="21">
                  <c:v>E_S_KZ3</c:v>
                </c:pt>
                <c:pt idx="22">
                  <c:v>E_KELIDAR_71</c:v>
                </c:pt>
                <c:pt idx="23">
                  <c:v>E_KA5</c:v>
                </c:pt>
                <c:pt idx="24">
                  <c:v>E_S_KN3</c:v>
                </c:pt>
                <c:pt idx="25">
                  <c:v>E_KELIDAR_70</c:v>
                </c:pt>
                <c:pt idx="26">
                  <c:v>E_KELIDAR_68</c:v>
                </c:pt>
                <c:pt idx="27">
                  <c:v>E_S_GMZ1</c:v>
                </c:pt>
                <c:pt idx="28">
                  <c:v>E_S_HZZ9</c:v>
                </c:pt>
                <c:pt idx="29">
                  <c:v>E_S_GMZ4</c:v>
                </c:pt>
                <c:pt idx="30">
                  <c:v>E_S_KZ6</c:v>
                </c:pt>
                <c:pt idx="31">
                  <c:v>E_I_D4</c:v>
                </c:pt>
                <c:pt idx="32">
                  <c:v>E_I_D2</c:v>
                </c:pt>
                <c:pt idx="33">
                  <c:v>E_I_D3</c:v>
                </c:pt>
                <c:pt idx="34">
                  <c:v>E_JR4</c:v>
                </c:pt>
                <c:pt idx="35">
                  <c:v>E_JR2</c:v>
                </c:pt>
                <c:pt idx="36">
                  <c:v>E_JR5</c:v>
                </c:pt>
                <c:pt idx="37">
                  <c:v>E_L_S4</c:v>
                </c:pt>
                <c:pt idx="38">
                  <c:v>E_L_S2</c:v>
                </c:pt>
                <c:pt idx="39">
                  <c:v>E_L_S1</c:v>
                </c:pt>
                <c:pt idx="40">
                  <c:v>E_L_T4N1</c:v>
                </c:pt>
                <c:pt idx="41">
                  <c:v>E_L_T3N2</c:v>
                </c:pt>
                <c:pt idx="42">
                  <c:v>E_L_T6</c:v>
                </c:pt>
                <c:pt idx="43">
                  <c:v>E_T1N2</c:v>
                </c:pt>
                <c:pt idx="44">
                  <c:v>E_P_IS_N_1_2</c:v>
                </c:pt>
                <c:pt idx="45">
                  <c:v>E_P_IS_N_1_1</c:v>
                </c:pt>
                <c:pt idx="46">
                  <c:v>E_BR6</c:v>
                </c:pt>
                <c:pt idx="47">
                  <c:v>E_BR4</c:v>
                </c:pt>
                <c:pt idx="48">
                  <c:v>E_L_T5N2</c:v>
                </c:pt>
                <c:pt idx="49">
                  <c:v>E_L_S3</c:v>
                </c:pt>
                <c:pt idx="50">
                  <c:v>E_K_52</c:v>
                </c:pt>
                <c:pt idx="51">
                  <c:v>E_K_54</c:v>
                </c:pt>
                <c:pt idx="52">
                  <c:v>E_K_49</c:v>
                </c:pt>
                <c:pt idx="53">
                  <c:v>E_O_31</c:v>
                </c:pt>
                <c:pt idx="54">
                  <c:v>E_P_27</c:v>
                </c:pt>
                <c:pt idx="55">
                  <c:v>E_P_48</c:v>
                </c:pt>
                <c:pt idx="56">
                  <c:v>E_P_46</c:v>
                </c:pt>
                <c:pt idx="57">
                  <c:v>E_P_43</c:v>
                </c:pt>
                <c:pt idx="58">
                  <c:v>E_P_47</c:v>
                </c:pt>
                <c:pt idx="59">
                  <c:v>E_O_IS_SHR_B1</c:v>
                </c:pt>
                <c:pt idx="60">
                  <c:v>E_P_5</c:v>
                </c:pt>
                <c:pt idx="61">
                  <c:v>E_P_16</c:v>
                </c:pt>
                <c:pt idx="62">
                  <c:v>E_P_26</c:v>
                </c:pt>
                <c:pt idx="63">
                  <c:v>E_P_4</c:v>
                </c:pt>
                <c:pt idx="64">
                  <c:v>E_S_22</c:v>
                </c:pt>
                <c:pt idx="65">
                  <c:v>E_S_18</c:v>
                </c:pt>
                <c:pt idx="66">
                  <c:v>E_S_19</c:v>
                </c:pt>
                <c:pt idx="67">
                  <c:v>E_SEM_TAZ_2_1</c:v>
                </c:pt>
                <c:pt idx="68">
                  <c:v>E_S_34</c:v>
                </c:pt>
                <c:pt idx="69">
                  <c:v>E_S_23</c:v>
                </c:pt>
                <c:pt idx="70">
                  <c:v>E_S_S_42</c:v>
                </c:pt>
                <c:pt idx="71">
                  <c:v>E_S_S_3</c:v>
                </c:pt>
                <c:pt idx="72">
                  <c:v>E_S_S_227_6</c:v>
                </c:pt>
                <c:pt idx="73">
                  <c:v>E_S_S_41</c:v>
                </c:pt>
                <c:pt idx="74">
                  <c:v>E_40</c:v>
                </c:pt>
                <c:pt idx="75">
                  <c:v>E_SEM_TAZ_21</c:v>
                </c:pt>
                <c:pt idx="76">
                  <c:v>E_SHIAN_10</c:v>
                </c:pt>
                <c:pt idx="77">
                  <c:v>E_SEM_TAZ_28</c:v>
                </c:pt>
                <c:pt idx="78">
                  <c:v>E_SHIAN_9</c:v>
                </c:pt>
                <c:pt idx="79">
                  <c:v>E_KERMANSHAH_39</c:v>
                </c:pt>
                <c:pt idx="80">
                  <c:v>E_S_GH1</c:v>
                </c:pt>
                <c:pt idx="81">
                  <c:v>E_S_63</c:v>
                </c:pt>
                <c:pt idx="82">
                  <c:v>E_S_GH4</c:v>
                </c:pt>
                <c:pt idx="83">
                  <c:v>E_S_64</c:v>
                </c:pt>
                <c:pt idx="84">
                  <c:v>E_S_66</c:v>
                </c:pt>
                <c:pt idx="85">
                  <c:v>E_S_65</c:v>
                </c:pt>
                <c:pt idx="86">
                  <c:v>E_G2</c:v>
                </c:pt>
                <c:pt idx="87">
                  <c:v>E_S_62</c:v>
                </c:pt>
              </c:strCache>
            </c:strRef>
          </c:cat>
          <c:val>
            <c:numRef>
              <c:f>'run27K5 (2)'!$P$3:$P$90</c:f>
              <c:numCache>
                <c:formatCode>General</c:formatCode>
                <c:ptCount val="88"/>
                <c:pt idx="0">
                  <c:v>0.999</c:v>
                </c:pt>
                <c:pt idx="1">
                  <c:v>0.999</c:v>
                </c:pt>
                <c:pt idx="2">
                  <c:v>0.999</c:v>
                </c:pt>
                <c:pt idx="3">
                  <c:v>0.99</c:v>
                </c:pt>
                <c:pt idx="4">
                  <c:v>0.97099999999999997</c:v>
                </c:pt>
                <c:pt idx="5">
                  <c:v>0.96899999999999997</c:v>
                </c:pt>
                <c:pt idx="6">
                  <c:v>0.95899999999999996</c:v>
                </c:pt>
                <c:pt idx="7">
                  <c:v>0.95899999999999996</c:v>
                </c:pt>
                <c:pt idx="8">
                  <c:v>0.94699999999999995</c:v>
                </c:pt>
                <c:pt idx="9">
                  <c:v>0.94599999999999995</c:v>
                </c:pt>
                <c:pt idx="10">
                  <c:v>0.91700000000000004</c:v>
                </c:pt>
                <c:pt idx="11">
                  <c:v>0.68300000000000005</c:v>
                </c:pt>
                <c:pt idx="12">
                  <c:v>0.67800000000000005</c:v>
                </c:pt>
                <c:pt idx="13">
                  <c:v>0.67800000000000005</c:v>
                </c:pt>
                <c:pt idx="14">
                  <c:v>0.65400000000000003</c:v>
                </c:pt>
                <c:pt idx="15">
                  <c:v>0.60599999999999998</c:v>
                </c:pt>
                <c:pt idx="16">
                  <c:v>0.60399999999999998</c:v>
                </c:pt>
                <c:pt idx="17">
                  <c:v>0.59599999999999997</c:v>
                </c:pt>
                <c:pt idx="18">
                  <c:v>0.58899999999999997</c:v>
                </c:pt>
                <c:pt idx="19">
                  <c:v>0.57099999999999995</c:v>
                </c:pt>
                <c:pt idx="20">
                  <c:v>0.54800000000000004</c:v>
                </c:pt>
                <c:pt idx="21">
                  <c:v>0.47099999999999997</c:v>
                </c:pt>
                <c:pt idx="22">
                  <c:v>0.46899999999999997</c:v>
                </c:pt>
                <c:pt idx="23">
                  <c:v>0.44500000000000001</c:v>
                </c:pt>
                <c:pt idx="24">
                  <c:v>0.379</c:v>
                </c:pt>
                <c:pt idx="25">
                  <c:v>0.32800000000000001</c:v>
                </c:pt>
                <c:pt idx="26">
                  <c:v>0.30099999999999999</c:v>
                </c:pt>
                <c:pt idx="27">
                  <c:v>0.29199999999999998</c:v>
                </c:pt>
                <c:pt idx="28">
                  <c:v>0.223</c:v>
                </c:pt>
                <c:pt idx="29">
                  <c:v>0.22</c:v>
                </c:pt>
                <c:pt idx="30">
                  <c:v>0.105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6.7000000000000004E-2</c:v>
                </c:pt>
                <c:pt idx="50">
                  <c:v>1.7999999999999999E-2</c:v>
                </c:pt>
                <c:pt idx="51">
                  <c:v>0.29199999999999998</c:v>
                </c:pt>
                <c:pt idx="52">
                  <c:v>0.34200000000000003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1E-3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.401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C8-46E7-A4E0-392E162E8AC1}"/>
            </c:ext>
          </c:extLst>
        </c:ser>
        <c:ser>
          <c:idx val="1"/>
          <c:order val="1"/>
          <c:spPr>
            <a:solidFill>
              <a:srgbClr val="00CC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run27K5 (2)'!$O$3:$O$90</c:f>
              <c:strCache>
                <c:ptCount val="88"/>
                <c:pt idx="0">
                  <c:v>E_O_75</c:v>
                </c:pt>
                <c:pt idx="1">
                  <c:v>E_O_76</c:v>
                </c:pt>
                <c:pt idx="2">
                  <c:v>E_O_77</c:v>
                </c:pt>
                <c:pt idx="3">
                  <c:v>E_O_73</c:v>
                </c:pt>
                <c:pt idx="4">
                  <c:v>E_O_SB</c:v>
                </c:pt>
                <c:pt idx="5">
                  <c:v>E_O_SB4</c:v>
                </c:pt>
                <c:pt idx="6">
                  <c:v>E_O_57</c:v>
                </c:pt>
                <c:pt idx="7">
                  <c:v>E_O_56</c:v>
                </c:pt>
                <c:pt idx="8">
                  <c:v>E_O_59</c:v>
                </c:pt>
                <c:pt idx="9">
                  <c:v>E_O_58</c:v>
                </c:pt>
                <c:pt idx="10">
                  <c:v>E_GH7</c:v>
                </c:pt>
                <c:pt idx="11">
                  <c:v>E_HZ6</c:v>
                </c:pt>
                <c:pt idx="12">
                  <c:v>E_O_sb5</c:v>
                </c:pt>
                <c:pt idx="13">
                  <c:v>E_HZ4</c:v>
                </c:pt>
                <c:pt idx="14">
                  <c:v>E_KELIDAR_69</c:v>
                </c:pt>
                <c:pt idx="15">
                  <c:v>E_O_74</c:v>
                </c:pt>
                <c:pt idx="16">
                  <c:v>E_S_KN1</c:v>
                </c:pt>
                <c:pt idx="17">
                  <c:v>E_O_SB6</c:v>
                </c:pt>
                <c:pt idx="18">
                  <c:v>E_O_55</c:v>
                </c:pt>
                <c:pt idx="19">
                  <c:v>E_O_60</c:v>
                </c:pt>
                <c:pt idx="20">
                  <c:v>E_S_KN6</c:v>
                </c:pt>
                <c:pt idx="21">
                  <c:v>E_S_KZ3</c:v>
                </c:pt>
                <c:pt idx="22">
                  <c:v>E_KELIDAR_71</c:v>
                </c:pt>
                <c:pt idx="23">
                  <c:v>E_KA5</c:v>
                </c:pt>
                <c:pt idx="24">
                  <c:v>E_S_KN3</c:v>
                </c:pt>
                <c:pt idx="25">
                  <c:v>E_KELIDAR_70</c:v>
                </c:pt>
                <c:pt idx="26">
                  <c:v>E_KELIDAR_68</c:v>
                </c:pt>
                <c:pt idx="27">
                  <c:v>E_S_GMZ1</c:v>
                </c:pt>
                <c:pt idx="28">
                  <c:v>E_S_HZZ9</c:v>
                </c:pt>
                <c:pt idx="29">
                  <c:v>E_S_GMZ4</c:v>
                </c:pt>
                <c:pt idx="30">
                  <c:v>E_S_KZ6</c:v>
                </c:pt>
                <c:pt idx="31">
                  <c:v>E_I_D4</c:v>
                </c:pt>
                <c:pt idx="32">
                  <c:v>E_I_D2</c:v>
                </c:pt>
                <c:pt idx="33">
                  <c:v>E_I_D3</c:v>
                </c:pt>
                <c:pt idx="34">
                  <c:v>E_JR4</c:v>
                </c:pt>
                <c:pt idx="35">
                  <c:v>E_JR2</c:v>
                </c:pt>
                <c:pt idx="36">
                  <c:v>E_JR5</c:v>
                </c:pt>
                <c:pt idx="37">
                  <c:v>E_L_S4</c:v>
                </c:pt>
                <c:pt idx="38">
                  <c:v>E_L_S2</c:v>
                </c:pt>
                <c:pt idx="39">
                  <c:v>E_L_S1</c:v>
                </c:pt>
                <c:pt idx="40">
                  <c:v>E_L_T4N1</c:v>
                </c:pt>
                <c:pt idx="41">
                  <c:v>E_L_T3N2</c:v>
                </c:pt>
                <c:pt idx="42">
                  <c:v>E_L_T6</c:v>
                </c:pt>
                <c:pt idx="43">
                  <c:v>E_T1N2</c:v>
                </c:pt>
                <c:pt idx="44">
                  <c:v>E_P_IS_N_1_2</c:v>
                </c:pt>
                <c:pt idx="45">
                  <c:v>E_P_IS_N_1_1</c:v>
                </c:pt>
                <c:pt idx="46">
                  <c:v>E_BR6</c:v>
                </c:pt>
                <c:pt idx="47">
                  <c:v>E_BR4</c:v>
                </c:pt>
                <c:pt idx="48">
                  <c:v>E_L_T5N2</c:v>
                </c:pt>
                <c:pt idx="49">
                  <c:v>E_L_S3</c:v>
                </c:pt>
                <c:pt idx="50">
                  <c:v>E_K_52</c:v>
                </c:pt>
                <c:pt idx="51">
                  <c:v>E_K_54</c:v>
                </c:pt>
                <c:pt idx="52">
                  <c:v>E_K_49</c:v>
                </c:pt>
                <c:pt idx="53">
                  <c:v>E_O_31</c:v>
                </c:pt>
                <c:pt idx="54">
                  <c:v>E_P_27</c:v>
                </c:pt>
                <c:pt idx="55">
                  <c:v>E_P_48</c:v>
                </c:pt>
                <c:pt idx="56">
                  <c:v>E_P_46</c:v>
                </c:pt>
                <c:pt idx="57">
                  <c:v>E_P_43</c:v>
                </c:pt>
                <c:pt idx="58">
                  <c:v>E_P_47</c:v>
                </c:pt>
                <c:pt idx="59">
                  <c:v>E_O_IS_SHR_B1</c:v>
                </c:pt>
                <c:pt idx="60">
                  <c:v>E_P_5</c:v>
                </c:pt>
                <c:pt idx="61">
                  <c:v>E_P_16</c:v>
                </c:pt>
                <c:pt idx="62">
                  <c:v>E_P_26</c:v>
                </c:pt>
                <c:pt idx="63">
                  <c:v>E_P_4</c:v>
                </c:pt>
                <c:pt idx="64">
                  <c:v>E_S_22</c:v>
                </c:pt>
                <c:pt idx="65">
                  <c:v>E_S_18</c:v>
                </c:pt>
                <c:pt idx="66">
                  <c:v>E_S_19</c:v>
                </c:pt>
                <c:pt idx="67">
                  <c:v>E_SEM_TAZ_2_1</c:v>
                </c:pt>
                <c:pt idx="68">
                  <c:v>E_S_34</c:v>
                </c:pt>
                <c:pt idx="69">
                  <c:v>E_S_23</c:v>
                </c:pt>
                <c:pt idx="70">
                  <c:v>E_S_S_42</c:v>
                </c:pt>
                <c:pt idx="71">
                  <c:v>E_S_S_3</c:v>
                </c:pt>
                <c:pt idx="72">
                  <c:v>E_S_S_227_6</c:v>
                </c:pt>
                <c:pt idx="73">
                  <c:v>E_S_S_41</c:v>
                </c:pt>
                <c:pt idx="74">
                  <c:v>E_40</c:v>
                </c:pt>
                <c:pt idx="75">
                  <c:v>E_SEM_TAZ_21</c:v>
                </c:pt>
                <c:pt idx="76">
                  <c:v>E_SHIAN_10</c:v>
                </c:pt>
                <c:pt idx="77">
                  <c:v>E_SEM_TAZ_28</c:v>
                </c:pt>
                <c:pt idx="78">
                  <c:v>E_SHIAN_9</c:v>
                </c:pt>
                <c:pt idx="79">
                  <c:v>E_KERMANSHAH_39</c:v>
                </c:pt>
                <c:pt idx="80">
                  <c:v>E_S_GH1</c:v>
                </c:pt>
                <c:pt idx="81">
                  <c:v>E_S_63</c:v>
                </c:pt>
                <c:pt idx="82">
                  <c:v>E_S_GH4</c:v>
                </c:pt>
                <c:pt idx="83">
                  <c:v>E_S_64</c:v>
                </c:pt>
                <c:pt idx="84">
                  <c:v>E_S_66</c:v>
                </c:pt>
                <c:pt idx="85">
                  <c:v>E_S_65</c:v>
                </c:pt>
                <c:pt idx="86">
                  <c:v>E_G2</c:v>
                </c:pt>
                <c:pt idx="87">
                  <c:v>E_S_62</c:v>
                </c:pt>
              </c:strCache>
            </c:strRef>
          </c:cat>
          <c:val>
            <c:numRef>
              <c:f>'run27K5 (2)'!$Q$3:$Q$90</c:f>
              <c:numCache>
                <c:formatCode>General</c:formatCode>
                <c:ptCount val="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01</c:v>
                </c:pt>
                <c:pt idx="4">
                  <c:v>2.9000000000000001E-2</c:v>
                </c:pt>
                <c:pt idx="5">
                  <c:v>3.1E-2</c:v>
                </c:pt>
                <c:pt idx="6">
                  <c:v>4.1000000000000002E-2</c:v>
                </c:pt>
                <c:pt idx="7">
                  <c:v>0.04</c:v>
                </c:pt>
                <c:pt idx="8">
                  <c:v>5.2999999999999999E-2</c:v>
                </c:pt>
                <c:pt idx="9">
                  <c:v>5.3999999999999999E-2</c:v>
                </c:pt>
                <c:pt idx="10">
                  <c:v>8.3000000000000004E-2</c:v>
                </c:pt>
                <c:pt idx="11">
                  <c:v>0.316</c:v>
                </c:pt>
                <c:pt idx="12">
                  <c:v>0.32200000000000001</c:v>
                </c:pt>
                <c:pt idx="13">
                  <c:v>0.32100000000000001</c:v>
                </c:pt>
                <c:pt idx="14">
                  <c:v>0.34599999999999997</c:v>
                </c:pt>
                <c:pt idx="15">
                  <c:v>0.39400000000000002</c:v>
                </c:pt>
                <c:pt idx="16">
                  <c:v>0.39600000000000002</c:v>
                </c:pt>
                <c:pt idx="17">
                  <c:v>0.40300000000000002</c:v>
                </c:pt>
                <c:pt idx="18">
                  <c:v>0.41099999999999998</c:v>
                </c:pt>
                <c:pt idx="19">
                  <c:v>0.42799999999999999</c:v>
                </c:pt>
                <c:pt idx="20">
                  <c:v>0.45200000000000001</c:v>
                </c:pt>
                <c:pt idx="21">
                  <c:v>0.52800000000000002</c:v>
                </c:pt>
                <c:pt idx="22">
                  <c:v>0.52900000000000003</c:v>
                </c:pt>
                <c:pt idx="23">
                  <c:v>0.55400000000000005</c:v>
                </c:pt>
                <c:pt idx="24">
                  <c:v>0.621</c:v>
                </c:pt>
                <c:pt idx="25">
                  <c:v>0.67200000000000004</c:v>
                </c:pt>
                <c:pt idx="26">
                  <c:v>0.69899999999999995</c:v>
                </c:pt>
                <c:pt idx="27">
                  <c:v>0.70799999999999996</c:v>
                </c:pt>
                <c:pt idx="28">
                  <c:v>0.77500000000000002</c:v>
                </c:pt>
                <c:pt idx="29">
                  <c:v>0.78</c:v>
                </c:pt>
                <c:pt idx="30">
                  <c:v>0.89500000000000002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.10299999999999999</c:v>
                </c:pt>
                <c:pt idx="47">
                  <c:v>0</c:v>
                </c:pt>
                <c:pt idx="48">
                  <c:v>0.10100000000000001</c:v>
                </c:pt>
                <c:pt idx="49">
                  <c:v>0</c:v>
                </c:pt>
                <c:pt idx="50">
                  <c:v>0.27800000000000002</c:v>
                </c:pt>
                <c:pt idx="51">
                  <c:v>1E-3</c:v>
                </c:pt>
                <c:pt idx="52">
                  <c:v>1.4999999999999999E-2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2E-3</c:v>
                </c:pt>
                <c:pt idx="87">
                  <c:v>1.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C8-46E7-A4E0-392E162E8AC1}"/>
            </c:ext>
          </c:extLst>
        </c:ser>
        <c:ser>
          <c:idx val="2"/>
          <c:order val="2"/>
          <c:spPr>
            <a:solidFill>
              <a:srgbClr val="66FF66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run27K5 (2)'!$O$3:$O$90</c:f>
              <c:strCache>
                <c:ptCount val="88"/>
                <c:pt idx="0">
                  <c:v>E_O_75</c:v>
                </c:pt>
                <c:pt idx="1">
                  <c:v>E_O_76</c:v>
                </c:pt>
                <c:pt idx="2">
                  <c:v>E_O_77</c:v>
                </c:pt>
                <c:pt idx="3">
                  <c:v>E_O_73</c:v>
                </c:pt>
                <c:pt idx="4">
                  <c:v>E_O_SB</c:v>
                </c:pt>
                <c:pt idx="5">
                  <c:v>E_O_SB4</c:v>
                </c:pt>
                <c:pt idx="6">
                  <c:v>E_O_57</c:v>
                </c:pt>
                <c:pt idx="7">
                  <c:v>E_O_56</c:v>
                </c:pt>
                <c:pt idx="8">
                  <c:v>E_O_59</c:v>
                </c:pt>
                <c:pt idx="9">
                  <c:v>E_O_58</c:v>
                </c:pt>
                <c:pt idx="10">
                  <c:v>E_GH7</c:v>
                </c:pt>
                <c:pt idx="11">
                  <c:v>E_HZ6</c:v>
                </c:pt>
                <c:pt idx="12">
                  <c:v>E_O_sb5</c:v>
                </c:pt>
                <c:pt idx="13">
                  <c:v>E_HZ4</c:v>
                </c:pt>
                <c:pt idx="14">
                  <c:v>E_KELIDAR_69</c:v>
                </c:pt>
                <c:pt idx="15">
                  <c:v>E_O_74</c:v>
                </c:pt>
                <c:pt idx="16">
                  <c:v>E_S_KN1</c:v>
                </c:pt>
                <c:pt idx="17">
                  <c:v>E_O_SB6</c:v>
                </c:pt>
                <c:pt idx="18">
                  <c:v>E_O_55</c:v>
                </c:pt>
                <c:pt idx="19">
                  <c:v>E_O_60</c:v>
                </c:pt>
                <c:pt idx="20">
                  <c:v>E_S_KN6</c:v>
                </c:pt>
                <c:pt idx="21">
                  <c:v>E_S_KZ3</c:v>
                </c:pt>
                <c:pt idx="22">
                  <c:v>E_KELIDAR_71</c:v>
                </c:pt>
                <c:pt idx="23">
                  <c:v>E_KA5</c:v>
                </c:pt>
                <c:pt idx="24">
                  <c:v>E_S_KN3</c:v>
                </c:pt>
                <c:pt idx="25">
                  <c:v>E_KELIDAR_70</c:v>
                </c:pt>
                <c:pt idx="26">
                  <c:v>E_KELIDAR_68</c:v>
                </c:pt>
                <c:pt idx="27">
                  <c:v>E_S_GMZ1</c:v>
                </c:pt>
                <c:pt idx="28">
                  <c:v>E_S_HZZ9</c:v>
                </c:pt>
                <c:pt idx="29">
                  <c:v>E_S_GMZ4</c:v>
                </c:pt>
                <c:pt idx="30">
                  <c:v>E_S_KZ6</c:v>
                </c:pt>
                <c:pt idx="31">
                  <c:v>E_I_D4</c:v>
                </c:pt>
                <c:pt idx="32">
                  <c:v>E_I_D2</c:v>
                </c:pt>
                <c:pt idx="33">
                  <c:v>E_I_D3</c:v>
                </c:pt>
                <c:pt idx="34">
                  <c:v>E_JR4</c:v>
                </c:pt>
                <c:pt idx="35">
                  <c:v>E_JR2</c:v>
                </c:pt>
                <c:pt idx="36">
                  <c:v>E_JR5</c:v>
                </c:pt>
                <c:pt idx="37">
                  <c:v>E_L_S4</c:v>
                </c:pt>
                <c:pt idx="38">
                  <c:v>E_L_S2</c:v>
                </c:pt>
                <c:pt idx="39">
                  <c:v>E_L_S1</c:v>
                </c:pt>
                <c:pt idx="40">
                  <c:v>E_L_T4N1</c:v>
                </c:pt>
                <c:pt idx="41">
                  <c:v>E_L_T3N2</c:v>
                </c:pt>
                <c:pt idx="42">
                  <c:v>E_L_T6</c:v>
                </c:pt>
                <c:pt idx="43">
                  <c:v>E_T1N2</c:v>
                </c:pt>
                <c:pt idx="44">
                  <c:v>E_P_IS_N_1_2</c:v>
                </c:pt>
                <c:pt idx="45">
                  <c:v>E_P_IS_N_1_1</c:v>
                </c:pt>
                <c:pt idx="46">
                  <c:v>E_BR6</c:v>
                </c:pt>
                <c:pt idx="47">
                  <c:v>E_BR4</c:v>
                </c:pt>
                <c:pt idx="48">
                  <c:v>E_L_T5N2</c:v>
                </c:pt>
                <c:pt idx="49">
                  <c:v>E_L_S3</c:v>
                </c:pt>
                <c:pt idx="50">
                  <c:v>E_K_52</c:v>
                </c:pt>
                <c:pt idx="51">
                  <c:v>E_K_54</c:v>
                </c:pt>
                <c:pt idx="52">
                  <c:v>E_K_49</c:v>
                </c:pt>
                <c:pt idx="53">
                  <c:v>E_O_31</c:v>
                </c:pt>
                <c:pt idx="54">
                  <c:v>E_P_27</c:v>
                </c:pt>
                <c:pt idx="55">
                  <c:v>E_P_48</c:v>
                </c:pt>
                <c:pt idx="56">
                  <c:v>E_P_46</c:v>
                </c:pt>
                <c:pt idx="57">
                  <c:v>E_P_43</c:v>
                </c:pt>
                <c:pt idx="58">
                  <c:v>E_P_47</c:v>
                </c:pt>
                <c:pt idx="59">
                  <c:v>E_O_IS_SHR_B1</c:v>
                </c:pt>
                <c:pt idx="60">
                  <c:v>E_P_5</c:v>
                </c:pt>
                <c:pt idx="61">
                  <c:v>E_P_16</c:v>
                </c:pt>
                <c:pt idx="62">
                  <c:v>E_P_26</c:v>
                </c:pt>
                <c:pt idx="63">
                  <c:v>E_P_4</c:v>
                </c:pt>
                <c:pt idx="64">
                  <c:v>E_S_22</c:v>
                </c:pt>
                <c:pt idx="65">
                  <c:v>E_S_18</c:v>
                </c:pt>
                <c:pt idx="66">
                  <c:v>E_S_19</c:v>
                </c:pt>
                <c:pt idx="67">
                  <c:v>E_SEM_TAZ_2_1</c:v>
                </c:pt>
                <c:pt idx="68">
                  <c:v>E_S_34</c:v>
                </c:pt>
                <c:pt idx="69">
                  <c:v>E_S_23</c:v>
                </c:pt>
                <c:pt idx="70">
                  <c:v>E_S_S_42</c:v>
                </c:pt>
                <c:pt idx="71">
                  <c:v>E_S_S_3</c:v>
                </c:pt>
                <c:pt idx="72">
                  <c:v>E_S_S_227_6</c:v>
                </c:pt>
                <c:pt idx="73">
                  <c:v>E_S_S_41</c:v>
                </c:pt>
                <c:pt idx="74">
                  <c:v>E_40</c:v>
                </c:pt>
                <c:pt idx="75">
                  <c:v>E_SEM_TAZ_21</c:v>
                </c:pt>
                <c:pt idx="76">
                  <c:v>E_SHIAN_10</c:v>
                </c:pt>
                <c:pt idx="77">
                  <c:v>E_SEM_TAZ_28</c:v>
                </c:pt>
                <c:pt idx="78">
                  <c:v>E_SHIAN_9</c:v>
                </c:pt>
                <c:pt idx="79">
                  <c:v>E_KERMANSHAH_39</c:v>
                </c:pt>
                <c:pt idx="80">
                  <c:v>E_S_GH1</c:v>
                </c:pt>
                <c:pt idx="81">
                  <c:v>E_S_63</c:v>
                </c:pt>
                <c:pt idx="82">
                  <c:v>E_S_GH4</c:v>
                </c:pt>
                <c:pt idx="83">
                  <c:v>E_S_64</c:v>
                </c:pt>
                <c:pt idx="84">
                  <c:v>E_S_66</c:v>
                </c:pt>
                <c:pt idx="85">
                  <c:v>E_S_65</c:v>
                </c:pt>
                <c:pt idx="86">
                  <c:v>E_G2</c:v>
                </c:pt>
                <c:pt idx="87">
                  <c:v>E_S_62</c:v>
                </c:pt>
              </c:strCache>
            </c:strRef>
          </c:cat>
          <c:val>
            <c:numRef>
              <c:f>'run27K5 (2)'!$R$3:$R$90</c:f>
              <c:numCache>
                <c:formatCode>General</c:formatCode>
                <c:ptCount val="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3.4000000000000002E-2</c:v>
                </c:pt>
                <c:pt idx="51">
                  <c:v>3.5000000000000003E-2</c:v>
                </c:pt>
                <c:pt idx="52">
                  <c:v>4.1000000000000002E-2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1E-3</c:v>
                </c:pt>
                <c:pt idx="80">
                  <c:v>0</c:v>
                </c:pt>
                <c:pt idx="81">
                  <c:v>3.0000000000000001E-3</c:v>
                </c:pt>
                <c:pt idx="82">
                  <c:v>5.0000000000000001E-3</c:v>
                </c:pt>
                <c:pt idx="83">
                  <c:v>8.9999999999999993E-3</c:v>
                </c:pt>
                <c:pt idx="84">
                  <c:v>0.01</c:v>
                </c:pt>
                <c:pt idx="85">
                  <c:v>2.4E-2</c:v>
                </c:pt>
                <c:pt idx="86">
                  <c:v>9.2999999999999999E-2</c:v>
                </c:pt>
                <c:pt idx="8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C8-46E7-A4E0-392E162E8AC1}"/>
            </c:ext>
          </c:extLst>
        </c:ser>
        <c:ser>
          <c:idx val="3"/>
          <c:order val="3"/>
          <c:spPr>
            <a:solidFill>
              <a:srgbClr val="0000FF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run27K5 (2)'!$O$3:$O$90</c:f>
              <c:strCache>
                <c:ptCount val="88"/>
                <c:pt idx="0">
                  <c:v>E_O_75</c:v>
                </c:pt>
                <c:pt idx="1">
                  <c:v>E_O_76</c:v>
                </c:pt>
                <c:pt idx="2">
                  <c:v>E_O_77</c:v>
                </c:pt>
                <c:pt idx="3">
                  <c:v>E_O_73</c:v>
                </c:pt>
                <c:pt idx="4">
                  <c:v>E_O_SB</c:v>
                </c:pt>
                <c:pt idx="5">
                  <c:v>E_O_SB4</c:v>
                </c:pt>
                <c:pt idx="6">
                  <c:v>E_O_57</c:v>
                </c:pt>
                <c:pt idx="7">
                  <c:v>E_O_56</c:v>
                </c:pt>
                <c:pt idx="8">
                  <c:v>E_O_59</c:v>
                </c:pt>
                <c:pt idx="9">
                  <c:v>E_O_58</c:v>
                </c:pt>
                <c:pt idx="10">
                  <c:v>E_GH7</c:v>
                </c:pt>
                <c:pt idx="11">
                  <c:v>E_HZ6</c:v>
                </c:pt>
                <c:pt idx="12">
                  <c:v>E_O_sb5</c:v>
                </c:pt>
                <c:pt idx="13">
                  <c:v>E_HZ4</c:v>
                </c:pt>
                <c:pt idx="14">
                  <c:v>E_KELIDAR_69</c:v>
                </c:pt>
                <c:pt idx="15">
                  <c:v>E_O_74</c:v>
                </c:pt>
                <c:pt idx="16">
                  <c:v>E_S_KN1</c:v>
                </c:pt>
                <c:pt idx="17">
                  <c:v>E_O_SB6</c:v>
                </c:pt>
                <c:pt idx="18">
                  <c:v>E_O_55</c:v>
                </c:pt>
                <c:pt idx="19">
                  <c:v>E_O_60</c:v>
                </c:pt>
                <c:pt idx="20">
                  <c:v>E_S_KN6</c:v>
                </c:pt>
                <c:pt idx="21">
                  <c:v>E_S_KZ3</c:v>
                </c:pt>
                <c:pt idx="22">
                  <c:v>E_KELIDAR_71</c:v>
                </c:pt>
                <c:pt idx="23">
                  <c:v>E_KA5</c:v>
                </c:pt>
                <c:pt idx="24">
                  <c:v>E_S_KN3</c:v>
                </c:pt>
                <c:pt idx="25">
                  <c:v>E_KELIDAR_70</c:v>
                </c:pt>
                <c:pt idx="26">
                  <c:v>E_KELIDAR_68</c:v>
                </c:pt>
                <c:pt idx="27">
                  <c:v>E_S_GMZ1</c:v>
                </c:pt>
                <c:pt idx="28">
                  <c:v>E_S_HZZ9</c:v>
                </c:pt>
                <c:pt idx="29">
                  <c:v>E_S_GMZ4</c:v>
                </c:pt>
                <c:pt idx="30">
                  <c:v>E_S_KZ6</c:v>
                </c:pt>
                <c:pt idx="31">
                  <c:v>E_I_D4</c:v>
                </c:pt>
                <c:pt idx="32">
                  <c:v>E_I_D2</c:v>
                </c:pt>
                <c:pt idx="33">
                  <c:v>E_I_D3</c:v>
                </c:pt>
                <c:pt idx="34">
                  <c:v>E_JR4</c:v>
                </c:pt>
                <c:pt idx="35">
                  <c:v>E_JR2</c:v>
                </c:pt>
                <c:pt idx="36">
                  <c:v>E_JR5</c:v>
                </c:pt>
                <c:pt idx="37">
                  <c:v>E_L_S4</c:v>
                </c:pt>
                <c:pt idx="38">
                  <c:v>E_L_S2</c:v>
                </c:pt>
                <c:pt idx="39">
                  <c:v>E_L_S1</c:v>
                </c:pt>
                <c:pt idx="40">
                  <c:v>E_L_T4N1</c:v>
                </c:pt>
                <c:pt idx="41">
                  <c:v>E_L_T3N2</c:v>
                </c:pt>
                <c:pt idx="42">
                  <c:v>E_L_T6</c:v>
                </c:pt>
                <c:pt idx="43">
                  <c:v>E_T1N2</c:v>
                </c:pt>
                <c:pt idx="44">
                  <c:v>E_P_IS_N_1_2</c:v>
                </c:pt>
                <c:pt idx="45">
                  <c:v>E_P_IS_N_1_1</c:v>
                </c:pt>
                <c:pt idx="46">
                  <c:v>E_BR6</c:v>
                </c:pt>
                <c:pt idx="47">
                  <c:v>E_BR4</c:v>
                </c:pt>
                <c:pt idx="48">
                  <c:v>E_L_T5N2</c:v>
                </c:pt>
                <c:pt idx="49">
                  <c:v>E_L_S3</c:v>
                </c:pt>
                <c:pt idx="50">
                  <c:v>E_K_52</c:v>
                </c:pt>
                <c:pt idx="51">
                  <c:v>E_K_54</c:v>
                </c:pt>
                <c:pt idx="52">
                  <c:v>E_K_49</c:v>
                </c:pt>
                <c:pt idx="53">
                  <c:v>E_O_31</c:v>
                </c:pt>
                <c:pt idx="54">
                  <c:v>E_P_27</c:v>
                </c:pt>
                <c:pt idx="55">
                  <c:v>E_P_48</c:v>
                </c:pt>
                <c:pt idx="56">
                  <c:v>E_P_46</c:v>
                </c:pt>
                <c:pt idx="57">
                  <c:v>E_P_43</c:v>
                </c:pt>
                <c:pt idx="58">
                  <c:v>E_P_47</c:v>
                </c:pt>
                <c:pt idx="59">
                  <c:v>E_O_IS_SHR_B1</c:v>
                </c:pt>
                <c:pt idx="60">
                  <c:v>E_P_5</c:v>
                </c:pt>
                <c:pt idx="61">
                  <c:v>E_P_16</c:v>
                </c:pt>
                <c:pt idx="62">
                  <c:v>E_P_26</c:v>
                </c:pt>
                <c:pt idx="63">
                  <c:v>E_P_4</c:v>
                </c:pt>
                <c:pt idx="64">
                  <c:v>E_S_22</c:v>
                </c:pt>
                <c:pt idx="65">
                  <c:v>E_S_18</c:v>
                </c:pt>
                <c:pt idx="66">
                  <c:v>E_S_19</c:v>
                </c:pt>
                <c:pt idx="67">
                  <c:v>E_SEM_TAZ_2_1</c:v>
                </c:pt>
                <c:pt idx="68">
                  <c:v>E_S_34</c:v>
                </c:pt>
                <c:pt idx="69">
                  <c:v>E_S_23</c:v>
                </c:pt>
                <c:pt idx="70">
                  <c:v>E_S_S_42</c:v>
                </c:pt>
                <c:pt idx="71">
                  <c:v>E_S_S_3</c:v>
                </c:pt>
                <c:pt idx="72">
                  <c:v>E_S_S_227_6</c:v>
                </c:pt>
                <c:pt idx="73">
                  <c:v>E_S_S_41</c:v>
                </c:pt>
                <c:pt idx="74">
                  <c:v>E_40</c:v>
                </c:pt>
                <c:pt idx="75">
                  <c:v>E_SEM_TAZ_21</c:v>
                </c:pt>
                <c:pt idx="76">
                  <c:v>E_SHIAN_10</c:v>
                </c:pt>
                <c:pt idx="77">
                  <c:v>E_SEM_TAZ_28</c:v>
                </c:pt>
                <c:pt idx="78">
                  <c:v>E_SHIAN_9</c:v>
                </c:pt>
                <c:pt idx="79">
                  <c:v>E_KERMANSHAH_39</c:v>
                </c:pt>
                <c:pt idx="80">
                  <c:v>E_S_GH1</c:v>
                </c:pt>
                <c:pt idx="81">
                  <c:v>E_S_63</c:v>
                </c:pt>
                <c:pt idx="82">
                  <c:v>E_S_GH4</c:v>
                </c:pt>
                <c:pt idx="83">
                  <c:v>E_S_64</c:v>
                </c:pt>
                <c:pt idx="84">
                  <c:v>E_S_66</c:v>
                </c:pt>
                <c:pt idx="85">
                  <c:v>E_S_65</c:v>
                </c:pt>
                <c:pt idx="86">
                  <c:v>E_G2</c:v>
                </c:pt>
                <c:pt idx="87">
                  <c:v>E_S_62</c:v>
                </c:pt>
              </c:strCache>
            </c:strRef>
          </c:cat>
          <c:val>
            <c:numRef>
              <c:f>'run27K5 (2)'!$S$3:$S$90</c:f>
              <c:numCache>
                <c:formatCode>General</c:formatCode>
                <c:ptCount val="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E-3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E-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2E-3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0.89700000000000002</c:v>
                </c:pt>
                <c:pt idx="47">
                  <c:v>0.999</c:v>
                </c:pt>
                <c:pt idx="48">
                  <c:v>0.89900000000000002</c:v>
                </c:pt>
                <c:pt idx="49">
                  <c:v>0.93300000000000005</c:v>
                </c:pt>
                <c:pt idx="50">
                  <c:v>0.65600000000000003</c:v>
                </c:pt>
                <c:pt idx="51">
                  <c:v>0.65300000000000002</c:v>
                </c:pt>
                <c:pt idx="52">
                  <c:v>0.60099999999999998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1E-3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3.0000000000000001E-3</c:v>
                </c:pt>
                <c:pt idx="85">
                  <c:v>0</c:v>
                </c:pt>
                <c:pt idx="86">
                  <c:v>4.0000000000000001E-3</c:v>
                </c:pt>
                <c:pt idx="87">
                  <c:v>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1C8-46E7-A4E0-392E162E8AC1}"/>
            </c:ext>
          </c:extLst>
        </c:ser>
        <c:ser>
          <c:idx val="4"/>
          <c:order val="4"/>
          <c:spPr>
            <a:solidFill>
              <a:srgbClr val="FFFF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run27K5 (2)'!$O$3:$O$90</c:f>
              <c:strCache>
                <c:ptCount val="88"/>
                <c:pt idx="0">
                  <c:v>E_O_75</c:v>
                </c:pt>
                <c:pt idx="1">
                  <c:v>E_O_76</c:v>
                </c:pt>
                <c:pt idx="2">
                  <c:v>E_O_77</c:v>
                </c:pt>
                <c:pt idx="3">
                  <c:v>E_O_73</c:v>
                </c:pt>
                <c:pt idx="4">
                  <c:v>E_O_SB</c:v>
                </c:pt>
                <c:pt idx="5">
                  <c:v>E_O_SB4</c:v>
                </c:pt>
                <c:pt idx="6">
                  <c:v>E_O_57</c:v>
                </c:pt>
                <c:pt idx="7">
                  <c:v>E_O_56</c:v>
                </c:pt>
                <c:pt idx="8">
                  <c:v>E_O_59</c:v>
                </c:pt>
                <c:pt idx="9">
                  <c:v>E_O_58</c:v>
                </c:pt>
                <c:pt idx="10">
                  <c:v>E_GH7</c:v>
                </c:pt>
                <c:pt idx="11">
                  <c:v>E_HZ6</c:v>
                </c:pt>
                <c:pt idx="12">
                  <c:v>E_O_sb5</c:v>
                </c:pt>
                <c:pt idx="13">
                  <c:v>E_HZ4</c:v>
                </c:pt>
                <c:pt idx="14">
                  <c:v>E_KELIDAR_69</c:v>
                </c:pt>
                <c:pt idx="15">
                  <c:v>E_O_74</c:v>
                </c:pt>
                <c:pt idx="16">
                  <c:v>E_S_KN1</c:v>
                </c:pt>
                <c:pt idx="17">
                  <c:v>E_O_SB6</c:v>
                </c:pt>
                <c:pt idx="18">
                  <c:v>E_O_55</c:v>
                </c:pt>
                <c:pt idx="19">
                  <c:v>E_O_60</c:v>
                </c:pt>
                <c:pt idx="20">
                  <c:v>E_S_KN6</c:v>
                </c:pt>
                <c:pt idx="21">
                  <c:v>E_S_KZ3</c:v>
                </c:pt>
                <c:pt idx="22">
                  <c:v>E_KELIDAR_71</c:v>
                </c:pt>
                <c:pt idx="23">
                  <c:v>E_KA5</c:v>
                </c:pt>
                <c:pt idx="24">
                  <c:v>E_S_KN3</c:v>
                </c:pt>
                <c:pt idx="25">
                  <c:v>E_KELIDAR_70</c:v>
                </c:pt>
                <c:pt idx="26">
                  <c:v>E_KELIDAR_68</c:v>
                </c:pt>
                <c:pt idx="27">
                  <c:v>E_S_GMZ1</c:v>
                </c:pt>
                <c:pt idx="28">
                  <c:v>E_S_HZZ9</c:v>
                </c:pt>
                <c:pt idx="29">
                  <c:v>E_S_GMZ4</c:v>
                </c:pt>
                <c:pt idx="30">
                  <c:v>E_S_KZ6</c:v>
                </c:pt>
                <c:pt idx="31">
                  <c:v>E_I_D4</c:v>
                </c:pt>
                <c:pt idx="32">
                  <c:v>E_I_D2</c:v>
                </c:pt>
                <c:pt idx="33">
                  <c:v>E_I_D3</c:v>
                </c:pt>
                <c:pt idx="34">
                  <c:v>E_JR4</c:v>
                </c:pt>
                <c:pt idx="35">
                  <c:v>E_JR2</c:v>
                </c:pt>
                <c:pt idx="36">
                  <c:v>E_JR5</c:v>
                </c:pt>
                <c:pt idx="37">
                  <c:v>E_L_S4</c:v>
                </c:pt>
                <c:pt idx="38">
                  <c:v>E_L_S2</c:v>
                </c:pt>
                <c:pt idx="39">
                  <c:v>E_L_S1</c:v>
                </c:pt>
                <c:pt idx="40">
                  <c:v>E_L_T4N1</c:v>
                </c:pt>
                <c:pt idx="41">
                  <c:v>E_L_T3N2</c:v>
                </c:pt>
                <c:pt idx="42">
                  <c:v>E_L_T6</c:v>
                </c:pt>
                <c:pt idx="43">
                  <c:v>E_T1N2</c:v>
                </c:pt>
                <c:pt idx="44">
                  <c:v>E_P_IS_N_1_2</c:v>
                </c:pt>
                <c:pt idx="45">
                  <c:v>E_P_IS_N_1_1</c:v>
                </c:pt>
                <c:pt idx="46">
                  <c:v>E_BR6</c:v>
                </c:pt>
                <c:pt idx="47">
                  <c:v>E_BR4</c:v>
                </c:pt>
                <c:pt idx="48">
                  <c:v>E_L_T5N2</c:v>
                </c:pt>
                <c:pt idx="49">
                  <c:v>E_L_S3</c:v>
                </c:pt>
                <c:pt idx="50">
                  <c:v>E_K_52</c:v>
                </c:pt>
                <c:pt idx="51">
                  <c:v>E_K_54</c:v>
                </c:pt>
                <c:pt idx="52">
                  <c:v>E_K_49</c:v>
                </c:pt>
                <c:pt idx="53">
                  <c:v>E_O_31</c:v>
                </c:pt>
                <c:pt idx="54">
                  <c:v>E_P_27</c:v>
                </c:pt>
                <c:pt idx="55">
                  <c:v>E_P_48</c:v>
                </c:pt>
                <c:pt idx="56">
                  <c:v>E_P_46</c:v>
                </c:pt>
                <c:pt idx="57">
                  <c:v>E_P_43</c:v>
                </c:pt>
                <c:pt idx="58">
                  <c:v>E_P_47</c:v>
                </c:pt>
                <c:pt idx="59">
                  <c:v>E_O_IS_SHR_B1</c:v>
                </c:pt>
                <c:pt idx="60">
                  <c:v>E_P_5</c:v>
                </c:pt>
                <c:pt idx="61">
                  <c:v>E_P_16</c:v>
                </c:pt>
                <c:pt idx="62">
                  <c:v>E_P_26</c:v>
                </c:pt>
                <c:pt idx="63">
                  <c:v>E_P_4</c:v>
                </c:pt>
                <c:pt idx="64">
                  <c:v>E_S_22</c:v>
                </c:pt>
                <c:pt idx="65">
                  <c:v>E_S_18</c:v>
                </c:pt>
                <c:pt idx="66">
                  <c:v>E_S_19</c:v>
                </c:pt>
                <c:pt idx="67">
                  <c:v>E_SEM_TAZ_2_1</c:v>
                </c:pt>
                <c:pt idx="68">
                  <c:v>E_S_34</c:v>
                </c:pt>
                <c:pt idx="69">
                  <c:v>E_S_23</c:v>
                </c:pt>
                <c:pt idx="70">
                  <c:v>E_S_S_42</c:v>
                </c:pt>
                <c:pt idx="71">
                  <c:v>E_S_S_3</c:v>
                </c:pt>
                <c:pt idx="72">
                  <c:v>E_S_S_227_6</c:v>
                </c:pt>
                <c:pt idx="73">
                  <c:v>E_S_S_41</c:v>
                </c:pt>
                <c:pt idx="74">
                  <c:v>E_40</c:v>
                </c:pt>
                <c:pt idx="75">
                  <c:v>E_SEM_TAZ_21</c:v>
                </c:pt>
                <c:pt idx="76">
                  <c:v>E_SHIAN_10</c:v>
                </c:pt>
                <c:pt idx="77">
                  <c:v>E_SEM_TAZ_28</c:v>
                </c:pt>
                <c:pt idx="78">
                  <c:v>E_SHIAN_9</c:v>
                </c:pt>
                <c:pt idx="79">
                  <c:v>E_KERMANSHAH_39</c:v>
                </c:pt>
                <c:pt idx="80">
                  <c:v>E_S_GH1</c:v>
                </c:pt>
                <c:pt idx="81">
                  <c:v>E_S_63</c:v>
                </c:pt>
                <c:pt idx="82">
                  <c:v>E_S_GH4</c:v>
                </c:pt>
                <c:pt idx="83">
                  <c:v>E_S_64</c:v>
                </c:pt>
                <c:pt idx="84">
                  <c:v>E_S_66</c:v>
                </c:pt>
                <c:pt idx="85">
                  <c:v>E_S_65</c:v>
                </c:pt>
                <c:pt idx="86">
                  <c:v>E_G2</c:v>
                </c:pt>
                <c:pt idx="87">
                  <c:v>E_S_62</c:v>
                </c:pt>
              </c:strCache>
            </c:strRef>
          </c:cat>
          <c:val>
            <c:numRef>
              <c:f>'run27K5 (2)'!$T$3:$T$90</c:f>
              <c:numCache>
                <c:formatCode>General</c:formatCode>
                <c:ptCount val="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1</c:v>
                </c:pt>
                <c:pt idx="54">
                  <c:v>1</c:v>
                </c:pt>
                <c:pt idx="55">
                  <c:v>1</c:v>
                </c:pt>
                <c:pt idx="56">
                  <c:v>1</c:v>
                </c:pt>
                <c:pt idx="57">
                  <c:v>1</c:v>
                </c:pt>
                <c:pt idx="58">
                  <c:v>1</c:v>
                </c:pt>
                <c:pt idx="59">
                  <c:v>0.999</c:v>
                </c:pt>
                <c:pt idx="60">
                  <c:v>0.999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1C8-46E7-A4E0-392E162E8AC1}"/>
            </c:ext>
          </c:extLst>
        </c:ser>
        <c:ser>
          <c:idx val="5"/>
          <c:order val="5"/>
          <c:spPr>
            <a:solidFill>
              <a:srgbClr val="FF3399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run27K5 (2)'!$O$3:$O$90</c:f>
              <c:strCache>
                <c:ptCount val="88"/>
                <c:pt idx="0">
                  <c:v>E_O_75</c:v>
                </c:pt>
                <c:pt idx="1">
                  <c:v>E_O_76</c:v>
                </c:pt>
                <c:pt idx="2">
                  <c:v>E_O_77</c:v>
                </c:pt>
                <c:pt idx="3">
                  <c:v>E_O_73</c:v>
                </c:pt>
                <c:pt idx="4">
                  <c:v>E_O_SB</c:v>
                </c:pt>
                <c:pt idx="5">
                  <c:v>E_O_SB4</c:v>
                </c:pt>
                <c:pt idx="6">
                  <c:v>E_O_57</c:v>
                </c:pt>
                <c:pt idx="7">
                  <c:v>E_O_56</c:v>
                </c:pt>
                <c:pt idx="8">
                  <c:v>E_O_59</c:v>
                </c:pt>
                <c:pt idx="9">
                  <c:v>E_O_58</c:v>
                </c:pt>
                <c:pt idx="10">
                  <c:v>E_GH7</c:v>
                </c:pt>
                <c:pt idx="11">
                  <c:v>E_HZ6</c:v>
                </c:pt>
                <c:pt idx="12">
                  <c:v>E_O_sb5</c:v>
                </c:pt>
                <c:pt idx="13">
                  <c:v>E_HZ4</c:v>
                </c:pt>
                <c:pt idx="14">
                  <c:v>E_KELIDAR_69</c:v>
                </c:pt>
                <c:pt idx="15">
                  <c:v>E_O_74</c:v>
                </c:pt>
                <c:pt idx="16">
                  <c:v>E_S_KN1</c:v>
                </c:pt>
                <c:pt idx="17">
                  <c:v>E_O_SB6</c:v>
                </c:pt>
                <c:pt idx="18">
                  <c:v>E_O_55</c:v>
                </c:pt>
                <c:pt idx="19">
                  <c:v>E_O_60</c:v>
                </c:pt>
                <c:pt idx="20">
                  <c:v>E_S_KN6</c:v>
                </c:pt>
                <c:pt idx="21">
                  <c:v>E_S_KZ3</c:v>
                </c:pt>
                <c:pt idx="22">
                  <c:v>E_KELIDAR_71</c:v>
                </c:pt>
                <c:pt idx="23">
                  <c:v>E_KA5</c:v>
                </c:pt>
                <c:pt idx="24">
                  <c:v>E_S_KN3</c:v>
                </c:pt>
                <c:pt idx="25">
                  <c:v>E_KELIDAR_70</c:v>
                </c:pt>
                <c:pt idx="26">
                  <c:v>E_KELIDAR_68</c:v>
                </c:pt>
                <c:pt idx="27">
                  <c:v>E_S_GMZ1</c:v>
                </c:pt>
                <c:pt idx="28">
                  <c:v>E_S_HZZ9</c:v>
                </c:pt>
                <c:pt idx="29">
                  <c:v>E_S_GMZ4</c:v>
                </c:pt>
                <c:pt idx="30">
                  <c:v>E_S_KZ6</c:v>
                </c:pt>
                <c:pt idx="31">
                  <c:v>E_I_D4</c:v>
                </c:pt>
                <c:pt idx="32">
                  <c:v>E_I_D2</c:v>
                </c:pt>
                <c:pt idx="33">
                  <c:v>E_I_D3</c:v>
                </c:pt>
                <c:pt idx="34">
                  <c:v>E_JR4</c:v>
                </c:pt>
                <c:pt idx="35">
                  <c:v>E_JR2</c:v>
                </c:pt>
                <c:pt idx="36">
                  <c:v>E_JR5</c:v>
                </c:pt>
                <c:pt idx="37">
                  <c:v>E_L_S4</c:v>
                </c:pt>
                <c:pt idx="38">
                  <c:v>E_L_S2</c:v>
                </c:pt>
                <c:pt idx="39">
                  <c:v>E_L_S1</c:v>
                </c:pt>
                <c:pt idx="40">
                  <c:v>E_L_T4N1</c:v>
                </c:pt>
                <c:pt idx="41">
                  <c:v>E_L_T3N2</c:v>
                </c:pt>
                <c:pt idx="42">
                  <c:v>E_L_T6</c:v>
                </c:pt>
                <c:pt idx="43">
                  <c:v>E_T1N2</c:v>
                </c:pt>
                <c:pt idx="44">
                  <c:v>E_P_IS_N_1_2</c:v>
                </c:pt>
                <c:pt idx="45">
                  <c:v>E_P_IS_N_1_1</c:v>
                </c:pt>
                <c:pt idx="46">
                  <c:v>E_BR6</c:v>
                </c:pt>
                <c:pt idx="47">
                  <c:v>E_BR4</c:v>
                </c:pt>
                <c:pt idx="48">
                  <c:v>E_L_T5N2</c:v>
                </c:pt>
                <c:pt idx="49">
                  <c:v>E_L_S3</c:v>
                </c:pt>
                <c:pt idx="50">
                  <c:v>E_K_52</c:v>
                </c:pt>
                <c:pt idx="51">
                  <c:v>E_K_54</c:v>
                </c:pt>
                <c:pt idx="52">
                  <c:v>E_K_49</c:v>
                </c:pt>
                <c:pt idx="53">
                  <c:v>E_O_31</c:v>
                </c:pt>
                <c:pt idx="54">
                  <c:v>E_P_27</c:v>
                </c:pt>
                <c:pt idx="55">
                  <c:v>E_P_48</c:v>
                </c:pt>
                <c:pt idx="56">
                  <c:v>E_P_46</c:v>
                </c:pt>
                <c:pt idx="57">
                  <c:v>E_P_43</c:v>
                </c:pt>
                <c:pt idx="58">
                  <c:v>E_P_47</c:v>
                </c:pt>
                <c:pt idx="59">
                  <c:v>E_O_IS_SHR_B1</c:v>
                </c:pt>
                <c:pt idx="60">
                  <c:v>E_P_5</c:v>
                </c:pt>
                <c:pt idx="61">
                  <c:v>E_P_16</c:v>
                </c:pt>
                <c:pt idx="62">
                  <c:v>E_P_26</c:v>
                </c:pt>
                <c:pt idx="63">
                  <c:v>E_P_4</c:v>
                </c:pt>
                <c:pt idx="64">
                  <c:v>E_S_22</c:v>
                </c:pt>
                <c:pt idx="65">
                  <c:v>E_S_18</c:v>
                </c:pt>
                <c:pt idx="66">
                  <c:v>E_S_19</c:v>
                </c:pt>
                <c:pt idx="67">
                  <c:v>E_SEM_TAZ_2_1</c:v>
                </c:pt>
                <c:pt idx="68">
                  <c:v>E_S_34</c:v>
                </c:pt>
                <c:pt idx="69">
                  <c:v>E_S_23</c:v>
                </c:pt>
                <c:pt idx="70">
                  <c:v>E_S_S_42</c:v>
                </c:pt>
                <c:pt idx="71">
                  <c:v>E_S_S_3</c:v>
                </c:pt>
                <c:pt idx="72">
                  <c:v>E_S_S_227_6</c:v>
                </c:pt>
                <c:pt idx="73">
                  <c:v>E_S_S_41</c:v>
                </c:pt>
                <c:pt idx="74">
                  <c:v>E_40</c:v>
                </c:pt>
                <c:pt idx="75">
                  <c:v>E_SEM_TAZ_21</c:v>
                </c:pt>
                <c:pt idx="76">
                  <c:v>E_SHIAN_10</c:v>
                </c:pt>
                <c:pt idx="77">
                  <c:v>E_SEM_TAZ_28</c:v>
                </c:pt>
                <c:pt idx="78">
                  <c:v>E_SHIAN_9</c:v>
                </c:pt>
                <c:pt idx="79">
                  <c:v>E_KERMANSHAH_39</c:v>
                </c:pt>
                <c:pt idx="80">
                  <c:v>E_S_GH1</c:v>
                </c:pt>
                <c:pt idx="81">
                  <c:v>E_S_63</c:v>
                </c:pt>
                <c:pt idx="82">
                  <c:v>E_S_GH4</c:v>
                </c:pt>
                <c:pt idx="83">
                  <c:v>E_S_64</c:v>
                </c:pt>
                <c:pt idx="84">
                  <c:v>E_S_66</c:v>
                </c:pt>
                <c:pt idx="85">
                  <c:v>E_S_65</c:v>
                </c:pt>
                <c:pt idx="86">
                  <c:v>E_G2</c:v>
                </c:pt>
                <c:pt idx="87">
                  <c:v>E_S_62</c:v>
                </c:pt>
              </c:strCache>
            </c:strRef>
          </c:cat>
          <c:val>
            <c:numRef>
              <c:f>'run27K5 (2)'!$U$3:$U$90</c:f>
              <c:numCache>
                <c:formatCode>General</c:formatCode>
                <c:ptCount val="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1E-3</c:v>
                </c:pt>
                <c:pt idx="48">
                  <c:v>0</c:v>
                </c:pt>
                <c:pt idx="49">
                  <c:v>0</c:v>
                </c:pt>
                <c:pt idx="50">
                  <c:v>1.4E-2</c:v>
                </c:pt>
                <c:pt idx="51">
                  <c:v>1.9E-2</c:v>
                </c:pt>
                <c:pt idx="52">
                  <c:v>1E-3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1</c:v>
                </c:pt>
                <c:pt idx="62">
                  <c:v>1</c:v>
                </c:pt>
                <c:pt idx="63">
                  <c:v>0.999</c:v>
                </c:pt>
                <c:pt idx="64">
                  <c:v>1</c:v>
                </c:pt>
                <c:pt idx="65">
                  <c:v>1</c:v>
                </c:pt>
                <c:pt idx="66">
                  <c:v>0.999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1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1</c:v>
                </c:pt>
                <c:pt idx="79">
                  <c:v>0.999</c:v>
                </c:pt>
                <c:pt idx="80">
                  <c:v>0.999</c:v>
                </c:pt>
                <c:pt idx="81">
                  <c:v>0.997</c:v>
                </c:pt>
                <c:pt idx="82">
                  <c:v>0.995</c:v>
                </c:pt>
                <c:pt idx="83">
                  <c:v>0.99099999999999999</c:v>
                </c:pt>
                <c:pt idx="84">
                  <c:v>0.98599999999999999</c:v>
                </c:pt>
                <c:pt idx="85">
                  <c:v>0.97499999999999998</c:v>
                </c:pt>
                <c:pt idx="86">
                  <c:v>0.90100000000000002</c:v>
                </c:pt>
                <c:pt idx="87">
                  <c:v>0.581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1C8-46E7-A4E0-392E162E8A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1757185103"/>
        <c:axId val="1757181359"/>
      </c:barChart>
      <c:catAx>
        <c:axId val="17571851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7181359"/>
        <c:crosses val="autoZero"/>
        <c:auto val="1"/>
        <c:lblAlgn val="ctr"/>
        <c:lblOffset val="100"/>
        <c:noMultiLvlLbl val="0"/>
      </c:catAx>
      <c:valAx>
        <c:axId val="175718135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571851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3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875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339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2483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345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374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506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261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869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449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502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6FE15-6C28-4F14-893F-B0433B8A8242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F6D38-FE9B-4B33-8F92-FD35FDA3F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033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57200" y="5143500"/>
            <a:ext cx="1140142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S4: </a:t>
            </a:r>
            <a:r>
              <a:rPr lang="en-US" dirty="0" smtClean="0"/>
              <a:t>Genetic population groups as determined by STRUCTURE for K=6. </a:t>
            </a:r>
            <a:r>
              <a:rPr lang="en-US" dirty="0"/>
              <a:t>The subpopulations identified were </a:t>
            </a:r>
            <a:r>
              <a:rPr lang="en-US" i="1" dirty="0" err="1" smtClean="0"/>
              <a:t>olgae</a:t>
            </a:r>
            <a:r>
              <a:rPr lang="en-US" i="1" dirty="0" smtClean="0"/>
              <a:t>, </a:t>
            </a:r>
            <a:r>
              <a:rPr lang="en-US" i="1" dirty="0" err="1" smtClean="0"/>
              <a:t>stenophyllus</a:t>
            </a:r>
            <a:r>
              <a:rPr lang="en-US" dirty="0"/>
              <a:t>, </a:t>
            </a:r>
            <a:r>
              <a:rPr lang="en-US" i="1" dirty="0" err="1"/>
              <a:t>inderiensis</a:t>
            </a:r>
            <a:r>
              <a:rPr lang="en-US" dirty="0"/>
              <a:t>, </a:t>
            </a:r>
            <a:r>
              <a:rPr lang="en-US" i="1" dirty="0" err="1"/>
              <a:t>luteus</a:t>
            </a:r>
            <a:r>
              <a:rPr lang="en-US" dirty="0"/>
              <a:t>, </a:t>
            </a:r>
            <a:r>
              <a:rPr lang="en-US" i="1" dirty="0" err="1"/>
              <a:t>persicus</a:t>
            </a:r>
            <a:r>
              <a:rPr lang="en-US" i="1" dirty="0"/>
              <a:t> </a:t>
            </a:r>
            <a:r>
              <a:rPr lang="en-US" dirty="0"/>
              <a:t>and </a:t>
            </a:r>
            <a:r>
              <a:rPr lang="en-US" i="1" dirty="0" err="1"/>
              <a:t>spectabilis</a:t>
            </a:r>
            <a:r>
              <a:rPr lang="en-US" dirty="0"/>
              <a:t>. Colored vertical bars indicate </a:t>
            </a:r>
            <a:r>
              <a:rPr lang="en-US" dirty="0" smtClean="0"/>
              <a:t>the percentage </a:t>
            </a:r>
            <a:r>
              <a:rPr lang="en-US" dirty="0"/>
              <a:t>membership to different subpopulations. </a:t>
            </a:r>
            <a:r>
              <a:rPr lang="en-US" dirty="0" smtClean="0"/>
              <a:t>Genotypes </a:t>
            </a:r>
            <a:r>
              <a:rPr lang="en-US" dirty="0"/>
              <a:t>indicated with * had not been morphologically classified</a:t>
            </a:r>
            <a:r>
              <a:rPr lang="en-US" dirty="0" smtClean="0"/>
              <a:t>. ‘</a:t>
            </a:r>
            <a:r>
              <a:rPr lang="en-US" i="1" dirty="0" err="1" smtClean="0"/>
              <a:t>E.k</a:t>
            </a:r>
            <a:r>
              <a:rPr lang="en-US" i="1" dirty="0" smtClean="0"/>
              <a:t>.’ </a:t>
            </a:r>
            <a:r>
              <a:rPr lang="en-US" dirty="0" smtClean="0"/>
              <a:t>indicates </a:t>
            </a:r>
            <a:r>
              <a:rPr lang="en-US" i="1" dirty="0" smtClean="0"/>
              <a:t>E. </a:t>
            </a:r>
            <a:r>
              <a:rPr lang="en-US" i="1" dirty="0" err="1" smtClean="0"/>
              <a:t>kopet-daghensis</a:t>
            </a:r>
            <a:r>
              <a:rPr lang="en-US" dirty="0" smtClean="0"/>
              <a:t>.  Genotypes </a:t>
            </a:r>
            <a:r>
              <a:rPr lang="en-US" dirty="0"/>
              <a:t>indicated with </a:t>
            </a:r>
            <a:r>
              <a:rPr lang="en-US" i="1" dirty="0" smtClean="0"/>
              <a:t>‘E.s.’ </a:t>
            </a:r>
            <a:r>
              <a:rPr lang="en-US" dirty="0" smtClean="0"/>
              <a:t>were </a:t>
            </a:r>
            <a:r>
              <a:rPr lang="en-US" dirty="0"/>
              <a:t>morphologically classified as belonging to </a:t>
            </a:r>
            <a:r>
              <a:rPr lang="en-US" i="1" dirty="0" smtClean="0"/>
              <a:t>E. </a:t>
            </a:r>
            <a:r>
              <a:rPr lang="en-US" i="1" dirty="0" err="1" smtClean="0"/>
              <a:t>stenophyllus</a:t>
            </a:r>
            <a:r>
              <a:rPr lang="en-US" dirty="0" smtClean="0"/>
              <a:t> but had ≥50% membership to subpopulation </a:t>
            </a:r>
            <a:r>
              <a:rPr lang="en-US" i="1" dirty="0" err="1" smtClean="0"/>
              <a:t>olgae</a:t>
            </a:r>
            <a:r>
              <a:rPr lang="en-US" dirty="0" smtClean="0"/>
              <a:t>.</a:t>
            </a:r>
            <a:endParaRPr lang="en-US" dirty="0"/>
          </a:p>
          <a:p>
            <a:r>
              <a:rPr lang="en-US" dirty="0" smtClean="0"/>
              <a:t>  </a:t>
            </a:r>
            <a:endParaRPr lang="en-US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190625" y="1568678"/>
            <a:ext cx="23526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105093" y="1307068"/>
            <a:ext cx="6367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E. </a:t>
            </a:r>
            <a:r>
              <a:rPr lang="en-US" sz="1100" i="1" dirty="0" err="1" smtClean="0"/>
              <a:t>olgae</a:t>
            </a:r>
            <a:endParaRPr lang="en-US" sz="1100" i="1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3619500" y="1568678"/>
            <a:ext cx="10477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574581" y="1307068"/>
            <a:ext cx="10310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E. </a:t>
            </a:r>
            <a:r>
              <a:rPr lang="en-US" sz="1100" i="1" dirty="0" err="1" smtClean="0"/>
              <a:t>stenophyllus</a:t>
            </a:r>
            <a:endParaRPr lang="en-US" sz="11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2271701" y="156210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</a:t>
            </a:r>
            <a:endParaRPr lang="en-US" sz="1000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4733925" y="1568678"/>
            <a:ext cx="6477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4633942" y="1307068"/>
            <a:ext cx="9573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E. </a:t>
            </a:r>
            <a:r>
              <a:rPr lang="en-US" sz="1100" i="1" dirty="0" err="1"/>
              <a:t>i</a:t>
            </a:r>
            <a:r>
              <a:rPr lang="en-US" sz="1100" i="1" dirty="0" err="1" smtClean="0"/>
              <a:t>nderiensis</a:t>
            </a:r>
            <a:r>
              <a:rPr lang="en-US" sz="1100" dirty="0" smtClean="0"/>
              <a:t> </a:t>
            </a:r>
            <a:endParaRPr lang="en-US" sz="1100" i="1" dirty="0"/>
          </a:p>
        </p:txBody>
      </p:sp>
      <p:cxnSp>
        <p:nvCxnSpPr>
          <p:cNvPr id="23" name="Straight Connector 22"/>
          <p:cNvCxnSpPr/>
          <p:nvPr/>
        </p:nvCxnSpPr>
        <p:spPr>
          <a:xfrm>
            <a:off x="5467350" y="1568678"/>
            <a:ext cx="13430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780499" y="1307068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E. </a:t>
            </a:r>
            <a:r>
              <a:rPr lang="en-US" sz="1100" i="1" dirty="0" err="1" smtClean="0"/>
              <a:t>luteus</a:t>
            </a:r>
            <a:endParaRPr lang="en-US" sz="1100" i="1" dirty="0"/>
          </a:p>
        </p:txBody>
      </p:sp>
      <p:cxnSp>
        <p:nvCxnSpPr>
          <p:cNvPr id="27" name="Straight Connector 26"/>
          <p:cNvCxnSpPr/>
          <p:nvPr/>
        </p:nvCxnSpPr>
        <p:spPr>
          <a:xfrm>
            <a:off x="7258050" y="1568678"/>
            <a:ext cx="838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7268166" y="1307068"/>
            <a:ext cx="8130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E. </a:t>
            </a:r>
            <a:r>
              <a:rPr lang="en-US" sz="1100" i="1" dirty="0" err="1" smtClean="0"/>
              <a:t>persicus</a:t>
            </a:r>
            <a:r>
              <a:rPr lang="en-US" sz="1100" i="1" dirty="0" smtClean="0"/>
              <a:t> </a:t>
            </a:r>
            <a:endParaRPr lang="en-US" sz="1100" i="1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8172450" y="1568678"/>
            <a:ext cx="298132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8982121" y="1307068"/>
            <a:ext cx="9156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smtClean="0"/>
              <a:t>E. </a:t>
            </a:r>
            <a:r>
              <a:rPr lang="en-US" sz="1100" i="1" dirty="0" err="1" smtClean="0"/>
              <a:t>spectabilis</a:t>
            </a:r>
            <a:endParaRPr lang="en-US" sz="1100" i="1" dirty="0"/>
          </a:p>
        </p:txBody>
      </p:sp>
      <p:sp>
        <p:nvSpPr>
          <p:cNvPr id="33" name="TextBox 32"/>
          <p:cNvSpPr txBox="1"/>
          <p:nvPr/>
        </p:nvSpPr>
        <p:spPr>
          <a:xfrm>
            <a:off x="10139364" y="156210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</a:t>
            </a:r>
            <a:endParaRPr lang="en-US" sz="1000" dirty="0"/>
          </a:p>
        </p:txBody>
      </p:sp>
      <p:cxnSp>
        <p:nvCxnSpPr>
          <p:cNvPr id="45" name="Straight Connector 44"/>
          <p:cNvCxnSpPr/>
          <p:nvPr/>
        </p:nvCxnSpPr>
        <p:spPr>
          <a:xfrm>
            <a:off x="6915150" y="1568678"/>
            <a:ext cx="2571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6840185" y="1307068"/>
            <a:ext cx="3882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 smtClean="0"/>
              <a:t>E.k</a:t>
            </a:r>
            <a:r>
              <a:rPr lang="en-US" sz="1100" i="1" dirty="0" smtClean="0"/>
              <a:t>.</a:t>
            </a:r>
            <a:endParaRPr lang="en-US" sz="1100" i="1" dirty="0"/>
          </a:p>
        </p:txBody>
      </p:sp>
      <p:graphicFrame>
        <p:nvGraphicFramePr>
          <p:cNvPr id="47" name="Chart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8096874"/>
              </p:ext>
            </p:extLst>
          </p:nvPr>
        </p:nvGraphicFramePr>
        <p:xfrm>
          <a:off x="752478" y="1595511"/>
          <a:ext cx="1062037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9" name="TextBox 48"/>
          <p:cNvSpPr txBox="1"/>
          <p:nvPr/>
        </p:nvSpPr>
        <p:spPr>
          <a:xfrm>
            <a:off x="2919271" y="153526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/>
              <a:t>E.s.</a:t>
            </a:r>
            <a:endParaRPr lang="en-US" sz="1000" i="1" dirty="0"/>
          </a:p>
        </p:txBody>
      </p:sp>
      <p:sp>
        <p:nvSpPr>
          <p:cNvPr id="52" name="TextBox 51"/>
          <p:cNvSpPr txBox="1"/>
          <p:nvPr/>
        </p:nvSpPr>
        <p:spPr>
          <a:xfrm>
            <a:off x="3371722" y="153526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/>
              <a:t>E.s.</a:t>
            </a:r>
            <a:endParaRPr lang="en-US" sz="1000" i="1" dirty="0"/>
          </a:p>
        </p:txBody>
      </p:sp>
    </p:spTree>
    <p:extLst>
      <p:ext uri="{BB962C8B-B14F-4D97-AF65-F5344CB8AC3E}">
        <p14:creationId xmlns:p14="http://schemas.microsoft.com/office/powerpoint/2010/main" val="31477847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1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Franklin College - University of Georg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rien M. Devos</dc:creator>
  <cp:lastModifiedBy>Katrien M. Devos</cp:lastModifiedBy>
  <cp:revision>17</cp:revision>
  <dcterms:created xsi:type="dcterms:W3CDTF">2019-04-03T15:09:21Z</dcterms:created>
  <dcterms:modified xsi:type="dcterms:W3CDTF">2020-02-08T16:42:26Z</dcterms:modified>
</cp:coreProperties>
</file>